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88" r:id="rId3"/>
    <p:sldId id="28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9D1D7-7AB0-4C64-893B-8CFCB8F7F4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0CE0D8-0795-47E0-A575-9A45B845D7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199408-F261-4DFB-8689-AD14FD99F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925012-1291-4FF5-B64D-EC1E6B030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D013EC-5A8D-4AA8-9CF5-4A30A42EB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293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FC615-59AC-4E37-898C-6A9D0F284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319387-230F-4CE7-81A3-A3CEDA4C54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C029F-9B67-4F7F-82B1-A3F64F3F7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8BD7D-5FDB-400B-B6C9-3879F7C14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ED8C1D-B21F-4C2D-8EA7-15CEB2938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17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9D863F-B1A5-477A-B20F-D3C3533E02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515114-9ED2-484D-AA1C-9853AD592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6D923-6EC8-4203-992B-AD156E821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8DC7C3-3E74-425D-9BF7-EB3E81A5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A8753-F3C7-4158-B331-AEFF546D8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14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47E3A-20A8-4FF7-90FE-E74D899CE0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7EE4D3-A24F-4C72-AA2C-87BB893558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A17EC-A42C-4F0B-94FB-DAB755516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065B1-EFF5-456D-9EFA-C9A480DDF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C5EF8-4173-4A98-9E72-D2AD4F4EB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608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5DD56-E1F4-485D-90C0-18DDD959D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F8A7C0-1301-40B5-BE0D-F3987DE30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4C597-CBD1-4222-B576-D6C4CD672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844A95-966F-41EA-A713-30D012B72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87DE5-F58A-4A5F-BFAA-9DF2319D1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424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75151-DE75-441D-803D-3E81B2596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894850-7EAF-4B30-82DC-0A405F89F4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E317E2-53BC-4E3C-8251-18A947CFA7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DF1B70-C916-4A0C-A2E8-A5E6E1201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39FC10-486A-4E45-AE5A-952A87012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647F93-80AC-4C2A-8C19-B05911550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948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E49A6F-106A-4D59-A572-B8C63E5E39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38E78D-1342-43F9-8FD7-5335DD7342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324E4E-DBB5-4E13-85F3-8DFAD3D935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4083BE-8876-4F8C-9D49-DB70A22D48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7144A4-391B-4A30-8B15-B77AB37843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B52A73-D806-4467-81E1-C41C17803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A64590-851E-44BB-8479-DEB1B6420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B64C3A-2080-4D6F-ACF7-27F80AC0D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377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7C2D0-A68F-4EC6-A824-C3C30BFB62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F3B6AA-5162-4C97-9E07-C5D8A759C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62B012-01E6-4FD0-9D54-E823D344A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E822CF-FB68-4E8F-8D02-89BC4466E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187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0B577C-F874-4EDE-B080-49F9AE6E4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736298-33F3-4CC8-8EDF-0C4D9C445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C9F269-1036-4D0A-84F6-29C1E8A85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016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1E3CC-09D2-4FE2-A888-3AC42C7AD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6FFEB9-C68E-4D29-AF10-F1299DAD9D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C0B40-8125-4E77-930E-74313E31A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90B6F3-C7C0-47BA-A31D-1132E9D51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459CF1-26F7-4CC6-9152-9F661CD08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482FD-08D7-4310-9140-A04F9BBBB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293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6B16A-8DF3-4AC8-8798-FB7919955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271B69-D04B-4B08-B675-293BD82417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43D3B8-C900-4BC7-B78D-9C39623B7B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005B6-66C5-482D-81B2-17CD3992C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A01F98-3F78-408F-8A16-E6AAFB307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4818E9-26E9-4A70-B7EF-F24A5D62C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762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A4116E-779C-4892-8447-750223C58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821F7E-7516-41AE-9841-284C26FFB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85F743-AC1D-4AAC-B466-688FA25196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D91DA-E989-4AFD-A65F-1B16BB5A5403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8A434-45B4-4B28-9623-A2340C0761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D29F38-C088-47A6-AC5E-F4DC818093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1EA23-527E-420D-A748-D00BAEBF0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19910-056C-45DF-91F4-8F354B6674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58540" y="2502535"/>
            <a:ext cx="5074920" cy="1325563"/>
          </a:xfrm>
        </p:spPr>
        <p:txBody>
          <a:bodyPr/>
          <a:lstStyle/>
          <a:p>
            <a:r>
              <a:rPr lang="en-US" b="1" dirty="0"/>
              <a:t>Supplemental File S1 </a:t>
            </a:r>
          </a:p>
        </p:txBody>
      </p:sp>
    </p:spTree>
    <p:extLst>
      <p:ext uri="{BB962C8B-B14F-4D97-AF65-F5344CB8AC3E}">
        <p14:creationId xmlns:p14="http://schemas.microsoft.com/office/powerpoint/2010/main" val="281240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F387DB8-38EE-4223-907A-34E657D912CF}"/>
              </a:ext>
            </a:extLst>
          </p:cNvPr>
          <p:cNvGraphicFramePr>
            <a:graphicFrameLocks noGrp="1"/>
          </p:cNvGraphicFramePr>
          <p:nvPr/>
        </p:nvGraphicFramePr>
        <p:xfrm>
          <a:off x="2552226" y="1923995"/>
          <a:ext cx="7087547" cy="3405943"/>
        </p:xfrm>
        <a:graphic>
          <a:graphicData uri="http://schemas.openxmlformats.org/drawingml/2006/table">
            <a:tbl>
              <a:tblPr firstRow="1" firstCol="1" bandRow="1"/>
              <a:tblGrid>
                <a:gridCol w="5669352">
                  <a:extLst>
                    <a:ext uri="{9D8B030D-6E8A-4147-A177-3AD203B41FA5}">
                      <a16:colId xmlns:a16="http://schemas.microsoft.com/office/drawing/2014/main" val="1982019319"/>
                    </a:ext>
                  </a:extLst>
                </a:gridCol>
                <a:gridCol w="1418195">
                  <a:extLst>
                    <a:ext uri="{9D8B030D-6E8A-4147-A177-3AD203B41FA5}">
                      <a16:colId xmlns:a16="http://schemas.microsoft.com/office/drawing/2014/main" val="2482076990"/>
                    </a:ext>
                  </a:extLst>
                </a:gridCol>
              </a:tblGrid>
              <a:tr h="3939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ariable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747215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er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6 (44.1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7368867"/>
                  </a:ext>
                </a:extLst>
              </a:tr>
              <a:tr h="24264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ugh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6 (61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5016323"/>
                  </a:ext>
                </a:extLst>
              </a:tr>
              <a:tr h="24264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hortness of Breath 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 (76.3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6634474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re throa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7222442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ethargy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 (35.6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8108530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dach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5.1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876799"/>
                  </a:ext>
                </a:extLst>
              </a:tr>
              <a:tr h="24264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ss of Taste/Smell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 (10.2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7634975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neumoni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 (30.5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4593844"/>
                  </a:ext>
                </a:extLst>
              </a:tr>
              <a:tr h="24264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ypoxi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 (62.7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1523216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rgan dysfunction/failur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 (10.2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7159920"/>
                  </a:ext>
                </a:extLst>
              </a:tr>
              <a:tr h="25696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modynamic instability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5.1%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152242"/>
                  </a:ext>
                </a:extLst>
              </a:tr>
              <a:tr h="24264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spiratory distress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16.9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800827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4F685C46-1E87-4EC4-BE3B-8EB717E415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5295" y="1068344"/>
            <a:ext cx="660897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1. COVID-19 symptoms and clinical presentation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1608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5729300"/>
              </p:ext>
            </p:extLst>
          </p:nvPr>
        </p:nvGraphicFramePr>
        <p:xfrm>
          <a:off x="1274191" y="2319020"/>
          <a:ext cx="9367520" cy="2219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2091911651"/>
                    </a:ext>
                  </a:extLst>
                </a:gridCol>
                <a:gridCol w="3366347">
                  <a:extLst>
                    <a:ext uri="{9D8B030D-6E8A-4147-A177-3AD203B41FA5}">
                      <a16:colId xmlns:a16="http://schemas.microsoft.com/office/drawing/2014/main" val="857966008"/>
                    </a:ext>
                  </a:extLst>
                </a:gridCol>
                <a:gridCol w="3291840">
                  <a:extLst>
                    <a:ext uri="{9D8B030D-6E8A-4147-A177-3AD203B41FA5}">
                      <a16:colId xmlns:a16="http://schemas.microsoft.com/office/drawing/2014/main" val="4261197578"/>
                    </a:ext>
                  </a:extLst>
                </a:gridCol>
              </a:tblGrid>
              <a:tr h="298026">
                <a:tc>
                  <a:txBody>
                    <a:bodyPr/>
                    <a:lstStyle/>
                    <a:p>
                      <a:r>
                        <a:rPr lang="en-US" dirty="0"/>
                        <a:t>Prim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Forward sequen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everse</a:t>
                      </a:r>
                      <a:r>
                        <a:rPr lang="en-US" baseline="0" dirty="0"/>
                        <a:t> sequence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48631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MAV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GTGCTCACCAAGGTGTCTG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TCAGAGCTGCTGTCTAGCCA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57800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IFN-</a:t>
                      </a:r>
                      <a:r>
                        <a:rPr lang="el-GR" dirty="0"/>
                        <a:t>α</a:t>
                      </a:r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AAGGCTCCAGCCATCTCTG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CTGGTAGAGTTCGGTGCAGA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08017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IFN-</a:t>
                      </a:r>
                      <a:r>
                        <a:rPr lang="el-GR" dirty="0"/>
                        <a:t>α</a:t>
                      </a:r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GCTGTGATCTGCCTCAAA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GCCTTTTGGAACTGGTTGCC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3381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IFN-</a:t>
                      </a:r>
                      <a:r>
                        <a:rPr lang="el-GR" dirty="0"/>
                        <a:t>β</a:t>
                      </a:r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TGGATTCCTACAAAGAAGCAGC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CTCCTTCTGGAACTGCTGCA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2662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18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TGGAGTCATACGCATTCTG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AGCATTCCCAGTGCCTTG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040458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62172" y="1631095"/>
            <a:ext cx="6391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able 2: Primer sequence utilized for real time PCR analyses</a:t>
            </a:r>
          </a:p>
        </p:txBody>
      </p:sp>
    </p:spTree>
    <p:extLst>
      <p:ext uri="{BB962C8B-B14F-4D97-AF65-F5344CB8AC3E}">
        <p14:creationId xmlns:p14="http://schemas.microsoft.com/office/powerpoint/2010/main" val="3675795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23</Words>
  <Application>Microsoft Office PowerPoint</Application>
  <PresentationFormat>Widescreen</PresentationFormat>
  <Paragraphs>4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l File S1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le X </dc:title>
  <dc:creator>Hussain, Salik</dc:creator>
  <cp:lastModifiedBy>Hussain, Salik</cp:lastModifiedBy>
  <cp:revision>4</cp:revision>
  <dcterms:created xsi:type="dcterms:W3CDTF">2022-05-23T12:36:27Z</dcterms:created>
  <dcterms:modified xsi:type="dcterms:W3CDTF">2022-09-12T14:45:50Z</dcterms:modified>
</cp:coreProperties>
</file>